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8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464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007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91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998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584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736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165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782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735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545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978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C3D4A-5ED7-499A-8C09-8B1FCB234531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0324F-78E2-4CA7-AF47-B07A0CE0C6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639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556950" y="609600"/>
            <a:ext cx="8349050" cy="3199319"/>
            <a:chOff x="1556950" y="609600"/>
            <a:chExt cx="8349050" cy="3199319"/>
          </a:xfrm>
        </p:grpSpPr>
        <p:cxnSp>
          <p:nvCxnSpPr>
            <p:cNvPr id="35" name="Straight Connector 34"/>
            <p:cNvCxnSpPr/>
            <p:nvPr/>
          </p:nvCxnSpPr>
          <p:spPr>
            <a:xfrm>
              <a:off x="3460450" y="3504119"/>
              <a:ext cx="5577840" cy="0"/>
            </a:xfrm>
            <a:prstGeom prst="line">
              <a:avLst/>
            </a:prstGeom>
            <a:ln w="571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Rectangle 35"/>
            <p:cNvSpPr/>
            <p:nvPr/>
          </p:nvSpPr>
          <p:spPr>
            <a:xfrm>
              <a:off x="3661944" y="3275519"/>
              <a:ext cx="1627306" cy="5334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CMV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5410806" y="3275519"/>
              <a:ext cx="1627306" cy="533400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Cherry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7215989" y="3271923"/>
              <a:ext cx="1627306" cy="533400"/>
            </a:xfrm>
            <a:prstGeom prst="rect">
              <a:avLst/>
            </a:prstGeom>
            <a:solidFill>
              <a:srgbClr val="7030A0"/>
            </a:solidFill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luc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2590800" y="841796"/>
              <a:ext cx="7315200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Rectangle 22"/>
            <p:cNvSpPr/>
            <p:nvPr/>
          </p:nvSpPr>
          <p:spPr>
            <a:xfrm>
              <a:off x="2792294" y="613196"/>
              <a:ext cx="1627306" cy="5334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MV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541156" y="613196"/>
              <a:ext cx="1627306" cy="533400"/>
            </a:xfrm>
            <a:prstGeom prst="rect">
              <a:avLst/>
            </a:prstGeom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 err="1"/>
                <a:t>eGFP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6346339" y="609600"/>
              <a:ext cx="1627306" cy="533400"/>
            </a:xfrm>
            <a:prstGeom prst="rect">
              <a:avLst/>
            </a:prstGeom>
            <a:solidFill>
              <a:schemeClr val="accent6"/>
            </a:solidFill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S</a:t>
              </a:r>
              <a:endParaRPr lang="en-US" sz="1400" b="1" dirty="0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8168640" y="609600"/>
              <a:ext cx="1627306" cy="533400"/>
            </a:xfrm>
            <a:prstGeom prst="rect">
              <a:avLst/>
            </a:prstGeom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uc2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2585561" y="1913628"/>
              <a:ext cx="7315200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Rectangle 18"/>
            <p:cNvSpPr/>
            <p:nvPr/>
          </p:nvSpPr>
          <p:spPr>
            <a:xfrm>
              <a:off x="2787055" y="1685028"/>
              <a:ext cx="1627306" cy="5334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1</a:t>
              </a:r>
              <a:r>
                <a:rPr lang="el-G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535917" y="1685028"/>
              <a:ext cx="1627306" cy="533400"/>
            </a:xfrm>
            <a:prstGeom prst="rect">
              <a:avLst/>
            </a:prstGeom>
          </p:spPr>
          <p:style>
            <a:lnRef idx="0">
              <a:schemeClr val="accent3"/>
            </a:lnRef>
            <a:fillRef idx="3">
              <a:schemeClr val="accent3"/>
            </a:fillRef>
            <a:effectRef idx="3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 smtClean="0"/>
                <a:t>CXCR4-eGFP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6341100" y="1681432"/>
              <a:ext cx="1627306" cy="533400"/>
            </a:xfrm>
            <a:prstGeom prst="rect">
              <a:avLst/>
            </a:prstGeom>
            <a:solidFill>
              <a:schemeClr val="accent6"/>
            </a:solidFill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S</a:t>
              </a:r>
              <a:endParaRPr lang="en-US" sz="1400" b="1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8163401" y="1681432"/>
              <a:ext cx="1627306" cy="533400"/>
            </a:xfrm>
            <a:prstGeom prst="rect">
              <a:avLst/>
            </a:prstGeom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uc2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556951" y="683741"/>
              <a:ext cx="3871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556950" y="1728962"/>
              <a:ext cx="3871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556950" y="3271923"/>
              <a:ext cx="3871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1002980" y="4501897"/>
            <a:ext cx="1067623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.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of vector construct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troviral vector for double reporter gene for making MSC/Fluc2.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troviral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ctor of CXCR4 containing double reporter gene for makin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C-CXCR4/Fluc2.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ntiviral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le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double report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containing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lu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DAMB-231/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uc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4571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337752" y="4403204"/>
            <a:ext cx="1140116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FP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by FACS of MSC/CXCR4-Fluc2 cells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includ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ccessive gates: a first gate 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C-H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H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select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(P1), and for the histogram another gate (P2) drawn for confirm the GFP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cells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experiments were performed in triplicate use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nalyzing the means ± standard deviation (SD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516789" y="481107"/>
            <a:ext cx="10316645" cy="3170887"/>
            <a:chOff x="1038994" y="1238988"/>
            <a:chExt cx="10316645" cy="3170887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2"/>
            <a:srcRect l="6421" t="45597" r="4612" b="16590"/>
            <a:stretch/>
          </p:blipFill>
          <p:spPr>
            <a:xfrm>
              <a:off x="3192164" y="2892507"/>
              <a:ext cx="3529912" cy="1517368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3"/>
            <a:srcRect l="5996" t="46922" b="13113"/>
            <a:stretch/>
          </p:blipFill>
          <p:spPr>
            <a:xfrm>
              <a:off x="3192164" y="1238988"/>
              <a:ext cx="3606688" cy="155611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 rot="16200000">
              <a:off x="1029788" y="1707497"/>
              <a:ext cx="5945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C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652946" y="3307382"/>
              <a:ext cx="12337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C-CXCR4/Fluc2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9369" y="1401984"/>
              <a:ext cx="4256270" cy="298104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5792" t="7561" r="55695" b="53180"/>
            <a:stretch/>
          </p:blipFill>
          <p:spPr>
            <a:xfrm>
              <a:off x="1526660" y="1350727"/>
              <a:ext cx="1288211" cy="1332633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/>
            <a:srcRect l="6261" t="6372" r="56175" b="56052"/>
            <a:stretch/>
          </p:blipFill>
          <p:spPr>
            <a:xfrm>
              <a:off x="1526660" y="2921334"/>
              <a:ext cx="1408670" cy="142514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27358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7</TotalTime>
  <Words>138</Words>
  <Application>Microsoft Office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53</cp:revision>
  <dcterms:created xsi:type="dcterms:W3CDTF">2015-10-27T23:37:59Z</dcterms:created>
  <dcterms:modified xsi:type="dcterms:W3CDTF">2017-05-02T06:13:31Z</dcterms:modified>
</cp:coreProperties>
</file>